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77" r:id="rId2"/>
    <p:sldId id="279" r:id="rId3"/>
  </p:sldIdLst>
  <p:sldSz cx="8820150" cy="1216818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18"/>
  </p:normalViewPr>
  <p:slideViewPr>
    <p:cSldViewPr snapToGrid="0" snapToObjects="1">
      <p:cViewPr varScale="1">
        <p:scale>
          <a:sx n="51" d="100"/>
          <a:sy n="51" d="100"/>
        </p:scale>
        <p:origin x="2824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61511" y="1991415"/>
            <a:ext cx="7497128" cy="4236332"/>
          </a:xfrm>
        </p:spPr>
        <p:txBody>
          <a:bodyPr anchor="b"/>
          <a:lstStyle>
            <a:lvl1pPr algn="ctr">
              <a:defRPr sz="57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2519" y="6391116"/>
            <a:ext cx="6615113" cy="2937828"/>
          </a:xfrm>
        </p:spPr>
        <p:txBody>
          <a:bodyPr/>
          <a:lstStyle>
            <a:lvl1pPr marL="0" indent="0" algn="ctr">
              <a:buNone/>
              <a:defRPr sz="2315"/>
            </a:lvl1pPr>
            <a:lvl2pPr marL="441015" indent="0" algn="ctr">
              <a:buNone/>
              <a:defRPr sz="1929"/>
            </a:lvl2pPr>
            <a:lvl3pPr marL="882030" indent="0" algn="ctr">
              <a:buNone/>
              <a:defRPr sz="1736"/>
            </a:lvl3pPr>
            <a:lvl4pPr marL="1323045" indent="0" algn="ctr">
              <a:buNone/>
              <a:defRPr sz="1543"/>
            </a:lvl4pPr>
            <a:lvl5pPr marL="1764060" indent="0" algn="ctr">
              <a:buNone/>
              <a:defRPr sz="1543"/>
            </a:lvl5pPr>
            <a:lvl6pPr marL="2205076" indent="0" algn="ctr">
              <a:buNone/>
              <a:defRPr sz="1543"/>
            </a:lvl6pPr>
            <a:lvl7pPr marL="2646091" indent="0" algn="ctr">
              <a:buNone/>
              <a:defRPr sz="1543"/>
            </a:lvl7pPr>
            <a:lvl8pPr marL="3087106" indent="0" algn="ctr">
              <a:buNone/>
              <a:defRPr sz="1543"/>
            </a:lvl8pPr>
            <a:lvl9pPr marL="3528121" indent="0" algn="ctr">
              <a:buNone/>
              <a:defRPr sz="154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780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779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11920" y="647843"/>
            <a:ext cx="1901845" cy="103119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6386" y="647843"/>
            <a:ext cx="5595283" cy="103119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2913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548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1792" y="3033601"/>
            <a:ext cx="7607379" cy="5061627"/>
          </a:xfrm>
        </p:spPr>
        <p:txBody>
          <a:bodyPr anchor="b"/>
          <a:lstStyle>
            <a:lvl1pPr>
              <a:defRPr sz="57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1792" y="8143113"/>
            <a:ext cx="7607379" cy="2661790"/>
          </a:xfrm>
        </p:spPr>
        <p:txBody>
          <a:bodyPr/>
          <a:lstStyle>
            <a:lvl1pPr marL="0" indent="0">
              <a:buNone/>
              <a:defRPr sz="2315">
                <a:solidFill>
                  <a:schemeClr val="tx1"/>
                </a:solidFill>
              </a:defRPr>
            </a:lvl1pPr>
            <a:lvl2pPr marL="441015" indent="0">
              <a:buNone/>
              <a:defRPr sz="1929">
                <a:solidFill>
                  <a:schemeClr val="tx1">
                    <a:tint val="75000"/>
                  </a:schemeClr>
                </a:solidFill>
              </a:defRPr>
            </a:lvl2pPr>
            <a:lvl3pPr marL="882030" indent="0">
              <a:buNone/>
              <a:defRPr sz="1736">
                <a:solidFill>
                  <a:schemeClr val="tx1">
                    <a:tint val="75000"/>
                  </a:schemeClr>
                </a:solidFill>
              </a:defRPr>
            </a:lvl3pPr>
            <a:lvl4pPr marL="1323045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4pPr>
            <a:lvl5pPr marL="1764060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5pPr>
            <a:lvl6pPr marL="2205076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6pPr>
            <a:lvl7pPr marL="2646091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7pPr>
            <a:lvl8pPr marL="3087106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8pPr>
            <a:lvl9pPr marL="3528121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098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6385" y="3239216"/>
            <a:ext cx="3748564" cy="772060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5201" y="3239216"/>
            <a:ext cx="3748564" cy="772060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660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647846"/>
            <a:ext cx="7607379" cy="235195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7535" y="2982897"/>
            <a:ext cx="3731336" cy="1461872"/>
          </a:xfrm>
        </p:spPr>
        <p:txBody>
          <a:bodyPr anchor="b"/>
          <a:lstStyle>
            <a:lvl1pPr marL="0" indent="0">
              <a:buNone/>
              <a:defRPr sz="2315" b="1"/>
            </a:lvl1pPr>
            <a:lvl2pPr marL="441015" indent="0">
              <a:buNone/>
              <a:defRPr sz="1929" b="1"/>
            </a:lvl2pPr>
            <a:lvl3pPr marL="882030" indent="0">
              <a:buNone/>
              <a:defRPr sz="1736" b="1"/>
            </a:lvl3pPr>
            <a:lvl4pPr marL="1323045" indent="0">
              <a:buNone/>
              <a:defRPr sz="1543" b="1"/>
            </a:lvl4pPr>
            <a:lvl5pPr marL="1764060" indent="0">
              <a:buNone/>
              <a:defRPr sz="1543" b="1"/>
            </a:lvl5pPr>
            <a:lvl6pPr marL="2205076" indent="0">
              <a:buNone/>
              <a:defRPr sz="1543" b="1"/>
            </a:lvl6pPr>
            <a:lvl7pPr marL="2646091" indent="0">
              <a:buNone/>
              <a:defRPr sz="1543" b="1"/>
            </a:lvl7pPr>
            <a:lvl8pPr marL="3087106" indent="0">
              <a:buNone/>
              <a:defRPr sz="1543" b="1"/>
            </a:lvl8pPr>
            <a:lvl9pPr marL="3528121" indent="0">
              <a:buNone/>
              <a:defRPr sz="154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7535" y="4444769"/>
            <a:ext cx="3731336" cy="653758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65201" y="2982897"/>
            <a:ext cx="3749713" cy="1461872"/>
          </a:xfrm>
        </p:spPr>
        <p:txBody>
          <a:bodyPr anchor="b"/>
          <a:lstStyle>
            <a:lvl1pPr marL="0" indent="0">
              <a:buNone/>
              <a:defRPr sz="2315" b="1"/>
            </a:lvl1pPr>
            <a:lvl2pPr marL="441015" indent="0">
              <a:buNone/>
              <a:defRPr sz="1929" b="1"/>
            </a:lvl2pPr>
            <a:lvl3pPr marL="882030" indent="0">
              <a:buNone/>
              <a:defRPr sz="1736" b="1"/>
            </a:lvl3pPr>
            <a:lvl4pPr marL="1323045" indent="0">
              <a:buNone/>
              <a:defRPr sz="1543" b="1"/>
            </a:lvl4pPr>
            <a:lvl5pPr marL="1764060" indent="0">
              <a:buNone/>
              <a:defRPr sz="1543" b="1"/>
            </a:lvl5pPr>
            <a:lvl6pPr marL="2205076" indent="0">
              <a:buNone/>
              <a:defRPr sz="1543" b="1"/>
            </a:lvl6pPr>
            <a:lvl7pPr marL="2646091" indent="0">
              <a:buNone/>
              <a:defRPr sz="1543" b="1"/>
            </a:lvl7pPr>
            <a:lvl8pPr marL="3087106" indent="0">
              <a:buNone/>
              <a:defRPr sz="1543" b="1"/>
            </a:lvl8pPr>
            <a:lvl9pPr marL="3528121" indent="0">
              <a:buNone/>
              <a:defRPr sz="154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65201" y="4444769"/>
            <a:ext cx="3749713" cy="653758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1524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384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762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811212"/>
            <a:ext cx="2844728" cy="2839244"/>
          </a:xfrm>
        </p:spPr>
        <p:txBody>
          <a:bodyPr anchor="b"/>
          <a:lstStyle>
            <a:lvl1pPr>
              <a:defRPr sz="30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49713" y="1751997"/>
            <a:ext cx="4465201" cy="8647300"/>
          </a:xfrm>
        </p:spPr>
        <p:txBody>
          <a:bodyPr/>
          <a:lstStyle>
            <a:lvl1pPr>
              <a:defRPr sz="3087"/>
            </a:lvl1pPr>
            <a:lvl2pPr>
              <a:defRPr sz="2701"/>
            </a:lvl2pPr>
            <a:lvl3pPr>
              <a:defRPr sz="2315"/>
            </a:lvl3pPr>
            <a:lvl4pPr>
              <a:defRPr sz="1929"/>
            </a:lvl4pPr>
            <a:lvl5pPr>
              <a:defRPr sz="1929"/>
            </a:lvl5pPr>
            <a:lvl6pPr>
              <a:defRPr sz="1929"/>
            </a:lvl6pPr>
            <a:lvl7pPr>
              <a:defRPr sz="1929"/>
            </a:lvl7pPr>
            <a:lvl8pPr>
              <a:defRPr sz="1929"/>
            </a:lvl8pPr>
            <a:lvl9pPr>
              <a:defRPr sz="192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7534" y="3650456"/>
            <a:ext cx="2844728" cy="6762922"/>
          </a:xfrm>
        </p:spPr>
        <p:txBody>
          <a:bodyPr/>
          <a:lstStyle>
            <a:lvl1pPr marL="0" indent="0">
              <a:buNone/>
              <a:defRPr sz="1543"/>
            </a:lvl1pPr>
            <a:lvl2pPr marL="441015" indent="0">
              <a:buNone/>
              <a:defRPr sz="1350"/>
            </a:lvl2pPr>
            <a:lvl3pPr marL="882030" indent="0">
              <a:buNone/>
              <a:defRPr sz="1158"/>
            </a:lvl3pPr>
            <a:lvl4pPr marL="1323045" indent="0">
              <a:buNone/>
              <a:defRPr sz="965"/>
            </a:lvl4pPr>
            <a:lvl5pPr marL="1764060" indent="0">
              <a:buNone/>
              <a:defRPr sz="965"/>
            </a:lvl5pPr>
            <a:lvl6pPr marL="2205076" indent="0">
              <a:buNone/>
              <a:defRPr sz="965"/>
            </a:lvl6pPr>
            <a:lvl7pPr marL="2646091" indent="0">
              <a:buNone/>
              <a:defRPr sz="965"/>
            </a:lvl7pPr>
            <a:lvl8pPr marL="3087106" indent="0">
              <a:buNone/>
              <a:defRPr sz="965"/>
            </a:lvl8pPr>
            <a:lvl9pPr marL="3528121" indent="0">
              <a:buNone/>
              <a:defRPr sz="9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594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811212"/>
            <a:ext cx="2844728" cy="2839244"/>
          </a:xfrm>
        </p:spPr>
        <p:txBody>
          <a:bodyPr anchor="b"/>
          <a:lstStyle>
            <a:lvl1pPr>
              <a:defRPr sz="30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49713" y="1751997"/>
            <a:ext cx="4465201" cy="8647300"/>
          </a:xfrm>
        </p:spPr>
        <p:txBody>
          <a:bodyPr anchor="t"/>
          <a:lstStyle>
            <a:lvl1pPr marL="0" indent="0">
              <a:buNone/>
              <a:defRPr sz="3087"/>
            </a:lvl1pPr>
            <a:lvl2pPr marL="441015" indent="0">
              <a:buNone/>
              <a:defRPr sz="2701"/>
            </a:lvl2pPr>
            <a:lvl3pPr marL="882030" indent="0">
              <a:buNone/>
              <a:defRPr sz="2315"/>
            </a:lvl3pPr>
            <a:lvl4pPr marL="1323045" indent="0">
              <a:buNone/>
              <a:defRPr sz="1929"/>
            </a:lvl4pPr>
            <a:lvl5pPr marL="1764060" indent="0">
              <a:buNone/>
              <a:defRPr sz="1929"/>
            </a:lvl5pPr>
            <a:lvl6pPr marL="2205076" indent="0">
              <a:buNone/>
              <a:defRPr sz="1929"/>
            </a:lvl6pPr>
            <a:lvl7pPr marL="2646091" indent="0">
              <a:buNone/>
              <a:defRPr sz="1929"/>
            </a:lvl7pPr>
            <a:lvl8pPr marL="3087106" indent="0">
              <a:buNone/>
              <a:defRPr sz="1929"/>
            </a:lvl8pPr>
            <a:lvl9pPr marL="3528121" indent="0">
              <a:buNone/>
              <a:defRPr sz="192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7534" y="3650456"/>
            <a:ext cx="2844728" cy="6762922"/>
          </a:xfrm>
        </p:spPr>
        <p:txBody>
          <a:bodyPr/>
          <a:lstStyle>
            <a:lvl1pPr marL="0" indent="0">
              <a:buNone/>
              <a:defRPr sz="1543"/>
            </a:lvl1pPr>
            <a:lvl2pPr marL="441015" indent="0">
              <a:buNone/>
              <a:defRPr sz="1350"/>
            </a:lvl2pPr>
            <a:lvl3pPr marL="882030" indent="0">
              <a:buNone/>
              <a:defRPr sz="1158"/>
            </a:lvl3pPr>
            <a:lvl4pPr marL="1323045" indent="0">
              <a:buNone/>
              <a:defRPr sz="965"/>
            </a:lvl4pPr>
            <a:lvl5pPr marL="1764060" indent="0">
              <a:buNone/>
              <a:defRPr sz="965"/>
            </a:lvl5pPr>
            <a:lvl6pPr marL="2205076" indent="0">
              <a:buNone/>
              <a:defRPr sz="965"/>
            </a:lvl6pPr>
            <a:lvl7pPr marL="2646091" indent="0">
              <a:buNone/>
              <a:defRPr sz="965"/>
            </a:lvl7pPr>
            <a:lvl8pPr marL="3087106" indent="0">
              <a:buNone/>
              <a:defRPr sz="965"/>
            </a:lvl8pPr>
            <a:lvl9pPr marL="3528121" indent="0">
              <a:buNone/>
              <a:defRPr sz="9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625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6386" y="647846"/>
            <a:ext cx="7607379" cy="23519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6386" y="3239216"/>
            <a:ext cx="7607379" cy="77206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6385" y="11278110"/>
            <a:ext cx="1984534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21675" y="11278110"/>
            <a:ext cx="2976801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29231" y="11278110"/>
            <a:ext cx="1984534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4092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82030" rtl="0" eaLnBrk="1" latinLnBrk="0" hangingPunct="1">
        <a:lnSpc>
          <a:spcPct val="90000"/>
        </a:lnSpc>
        <a:spcBef>
          <a:spcPct val="0"/>
        </a:spcBef>
        <a:buNone/>
        <a:defRPr sz="424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0508" indent="-220508" algn="l" defTabSz="882030" rtl="0" eaLnBrk="1" latinLnBrk="0" hangingPunct="1">
        <a:lnSpc>
          <a:spcPct val="90000"/>
        </a:lnSpc>
        <a:spcBef>
          <a:spcPts val="965"/>
        </a:spcBef>
        <a:buFont typeface="Arial" panose="020B0604020202020204" pitchFamily="34" charset="0"/>
        <a:buChar char="•"/>
        <a:defRPr sz="2701" kern="1200">
          <a:solidFill>
            <a:schemeClr val="tx1"/>
          </a:solidFill>
          <a:latin typeface="+mn-lt"/>
          <a:ea typeface="+mn-ea"/>
          <a:cs typeface="+mn-cs"/>
        </a:defRPr>
      </a:lvl1pPr>
      <a:lvl2pPr marL="66152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2pPr>
      <a:lvl3pPr marL="1102538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929" kern="1200">
          <a:solidFill>
            <a:schemeClr val="tx1"/>
          </a:solidFill>
          <a:latin typeface="+mn-lt"/>
          <a:ea typeface="+mn-ea"/>
          <a:cs typeface="+mn-cs"/>
        </a:defRPr>
      </a:lvl3pPr>
      <a:lvl4pPr marL="154355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4pPr>
      <a:lvl5pPr marL="1984568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5pPr>
      <a:lvl6pPr marL="242558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6pPr>
      <a:lvl7pPr marL="2866598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7pPr>
      <a:lvl8pPr marL="330761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8pPr>
      <a:lvl9pPr marL="3748629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1pPr>
      <a:lvl2pPr marL="441015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2pPr>
      <a:lvl3pPr marL="882030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3pPr>
      <a:lvl4pPr marL="1323045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4pPr>
      <a:lvl5pPr marL="1764060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5pPr>
      <a:lvl6pPr marL="2205076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6pPr>
      <a:lvl7pPr marL="2646091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7pPr>
      <a:lvl8pPr marL="3087106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8pPr>
      <a:lvl9pPr marL="3528121" algn="l" defTabSz="882030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3FC3794-4BB3-DB45-9992-C7C7322DA2D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2028" r="-36" b="17547"/>
          <a:stretch/>
        </p:blipFill>
        <p:spPr>
          <a:xfrm>
            <a:off x="3174" y="1469036"/>
            <a:ext cx="8816976" cy="855938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0442141-68DF-B343-8B35-29E7E0D152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4949" y="551324"/>
            <a:ext cx="8353425" cy="646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396" eaLnBrk="1" hangingPunct="1">
              <a:defRPr/>
            </a:pPr>
            <a:r>
              <a:rPr lang="en-US" altLang="en-US" sz="1799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4 Fig: </a:t>
            </a:r>
            <a:r>
              <a:rPr lang="en-US" altLang="en-US" sz="1799" b="1" dirty="0">
                <a:solidFill>
                  <a:prstClr val="black"/>
                </a:solidFill>
                <a:latin typeface="Times New Roman" panose="02020603050405020304" pitchFamily="18" charset="0"/>
              </a:rPr>
              <a:t>Amplification efficiencies of the designed primers of all candidate reference genes in </a:t>
            </a:r>
            <a:r>
              <a:rPr lang="en-US" altLang="en-US" sz="1799" b="1" i="1" dirty="0">
                <a:solidFill>
                  <a:prstClr val="black"/>
                </a:solidFill>
                <a:latin typeface="Times New Roman" panose="02020603050405020304" pitchFamily="18" charset="0"/>
              </a:rPr>
              <a:t>C.sativa.</a:t>
            </a:r>
            <a:endParaRPr lang="en-IN" altLang="en-US" sz="1799" i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93236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F07119F-F7F0-A146-AFB0-271C3B7B413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506" b="21626"/>
          <a:stretch/>
        </p:blipFill>
        <p:spPr>
          <a:xfrm>
            <a:off x="0" y="104931"/>
            <a:ext cx="8820150" cy="88591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151031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</TotalTime>
  <Words>20</Words>
  <Application>Microsoft Macintosh PowerPoint</Application>
  <PresentationFormat>Custom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1_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kha dixit</dc:creator>
  <cp:lastModifiedBy>Microsoft Office User</cp:lastModifiedBy>
  <cp:revision>10</cp:revision>
  <cp:lastPrinted>2019-08-24T18:45:17Z</cp:lastPrinted>
  <dcterms:created xsi:type="dcterms:W3CDTF">2019-04-10T09:34:45Z</dcterms:created>
  <dcterms:modified xsi:type="dcterms:W3CDTF">2019-09-06T14:33:15Z</dcterms:modified>
</cp:coreProperties>
</file>